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434"/>
    <p:restoredTop sz="94689"/>
  </p:normalViewPr>
  <p:slideViewPr>
    <p:cSldViewPr snapToGrid="0" snapToObjects="1">
      <p:cViewPr varScale="1">
        <p:scale>
          <a:sx n="61" d="100"/>
          <a:sy n="61" d="100"/>
        </p:scale>
        <p:origin x="216" y="1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C95B1D-9CA8-0137-026B-A82D4EFFE4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8F3757-1BB0-35F6-5FD2-B7D9892D12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08F7B8-BF01-7B47-DD9D-13920E7EA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19632-5D7C-CD47-5E9B-381E6C4FE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ED36EA-5F80-3F2A-C4C0-DF3483C20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64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A1A84A-9D00-F59A-6CF5-966FCBD035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6EF85B-EA94-6BEF-2F1B-1DB421A81F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DF475F-8F44-74C0-3A28-7A1ADFA81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62DEE-4C76-E73B-B4EF-A6A8E3CA2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A76C4-BCFE-B961-53DC-467EAA3B5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67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F590DE-5189-361B-5167-6F65A37D28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E844A7-F63D-5D0A-2287-F33E61FB6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CBEF53-A05F-BA3D-7CB3-480B47795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5183B9-169F-E5B6-45DB-EC4B53642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7C203A-7E3C-4C09-9220-E44DFD3C5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399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C9930C-7753-125B-26A2-A3D38C5F1F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350212-B925-CC6C-74AF-0FB706134C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23D700-33CB-364B-92EF-59485E944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B1633-7085-2115-8610-7AFF1B157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788C5-824F-4AE4-35A6-6B83C4535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91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23DA3-DADE-5FAB-0C12-7CFD2D20F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580B1A-3595-7E0C-34C2-04C8795B87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F7A46C-BD71-0689-5063-36E56CFC0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9F20F-5756-B15C-54D3-C7F9BC104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0B0336-3AEF-36A6-29B0-41066BCBE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313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E8D7F-6911-167F-6765-D99DE9960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06F14D-C80D-7EFA-1B7A-C348AC48AB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42B9A3-B8C7-EF10-3384-7E4FF06CFB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0DAE99-BC67-AA97-BADA-CC96EE0EF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281B67-B937-3E9F-3A44-16165CB07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3B0B5A-C977-AC8E-F5FD-65181E4BB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09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05128-A837-07AF-A304-98024E3A5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9B5BF7-2C2E-1BB6-28CD-3A99183868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45BA61-151F-495E-1774-3EBFB3A40A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A031BD-6AAF-CC15-F3A3-C1457A8E48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6E3B89-EEC5-5A86-FEDA-114AC7D4B6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35EB6E-3C93-430B-B22A-1076B5C53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641F6D-ED63-7BD9-CCFC-D5B1EF15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3F13CF-FDF1-9EFD-C504-8FACBCD74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899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C13A9-AB35-02DA-558D-A06731D97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55132B-171A-4905-79C0-A2D8E3C52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FFFDA0-CE1A-3FA3-38BA-279539122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5162AA-0BF0-1323-B8B7-441A0166B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4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B1817D-B980-0F7C-A7BD-90ACF4058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F196F7-0E43-9F26-ECAD-9CB1201CC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84E2DD-0905-1398-BB7E-1E03EF822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56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0B36AF-6AE8-56A9-547F-B9B6A335C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4D7D29-8C40-2ACC-E55C-20D82B8F8C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ADCF35-942B-AFDF-571B-B0679DA21F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79B611-3CE6-7BD5-5EC8-B3D6F9591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E66F96-092B-E03C-58AA-8786CC82C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19BF24-EBBF-2509-BF74-212B8B126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218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5A140-8478-B163-4C9C-10AC96C49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75DD72-55E6-C0C7-B420-73B3D50BAA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DEA378-EE99-56F1-8EEF-538368ACB6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408CF0-5545-4D2A-B1D6-85000BF14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26096F-BFE5-72A9-7928-9EC427645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BF66BE-3ED7-67B1-B330-A27293162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918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4DC4DF-449F-A985-9FE9-8683919DF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5811D-C148-56E4-A2AC-2708C21537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CE70AC-1F75-6A62-7AC8-578717B3D7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09E82-FBBC-9B40-A45F-B64ECDC7C5F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F1CA0-BF5C-1770-FC8F-F816959464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A8571-4144-D491-E09C-E470F7F57D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713FB-B2C3-5843-BA7F-7A6D9E0CBC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942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42C524-727B-4180-BC89-27C552F9DD3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6D0C18-F84E-E569-FB56-DD1B0A9E0CA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1303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F320D-0A48-0433-5567-0803BB9D3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lci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78467B-BD3F-82CC-8549-B82AEB3271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it-IT" dirty="0"/>
              <a:t>8.0 mg/</a:t>
            </a:r>
            <a:r>
              <a:rPr lang="it-IT" dirty="0" err="1"/>
              <a:t>dL</a:t>
            </a:r>
            <a:r>
              <a:rPr lang="it-IT" dirty="0"/>
              <a:t> 							(8.6-10.5 mg/</a:t>
            </a:r>
            <a:r>
              <a:rPr lang="it-IT" dirty="0" err="1"/>
              <a:t>dL</a:t>
            </a:r>
            <a:r>
              <a:rPr lang="it-IT" dirty="0"/>
              <a:t>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49283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33548-310C-42FA-21F7-5E235727F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gnesi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D19CB-29D1-D90B-FC86-1C6CCD6233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.3 mg/dL							(1.6-2.6 mg/dL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39157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9EB62-1A10-1258-1B6F-6839C3827D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osphorou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6BC4A-4CB7-76DE-6524-2ED60D695F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3.5 mg/dL							(3.0-4.5 mg/dL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73022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80DAA2-39F9-6A35-8B75-4E6A992E2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oponin, low-sensitiv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9475E6-A7DE-2DF0-50B1-782B99FCE5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0.09 ng/L							(&lt;0.03 ng/L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50804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F8854-81A0-10EF-4B4F-300E4E15A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oponin, high-sensitivity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5806F3-AAA5-0EF2-8812-45B3C01ED2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da-DK" dirty="0"/>
              <a:t>90 </a:t>
            </a:r>
            <a:r>
              <a:rPr lang="da-DK" dirty="0" err="1"/>
              <a:t>ng</a:t>
            </a:r>
            <a:r>
              <a:rPr lang="da-DK" dirty="0"/>
              <a:t>/</a:t>
            </a:r>
            <a:r>
              <a:rPr lang="da-DK" dirty="0" err="1"/>
              <a:t>mL</a:t>
            </a:r>
            <a:r>
              <a:rPr lang="da-DK" dirty="0"/>
              <a:t>							(&lt;54 </a:t>
            </a:r>
            <a:r>
              <a:rPr lang="da-DK" dirty="0" err="1"/>
              <a:t>ng</a:t>
            </a:r>
            <a:r>
              <a:rPr lang="da-DK" dirty="0"/>
              <a:t>/</a:t>
            </a:r>
            <a:r>
              <a:rPr lang="da-DK" dirty="0" err="1"/>
              <a:t>mL</a:t>
            </a:r>
            <a:r>
              <a:rPr lang="da-DK" dirty="0"/>
              <a:t>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379266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A5D99-0F6C-DF02-D5B0-BD968DDC3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-dim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BBB14B-037A-00E2-109D-DB336F2709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da-DK" dirty="0"/>
              <a:t>1.4 ug/</a:t>
            </a:r>
            <a:r>
              <a:rPr lang="da-DK" dirty="0" err="1"/>
              <a:t>mL</a:t>
            </a:r>
            <a:r>
              <a:rPr lang="da-DK" dirty="0"/>
              <a:t>							(&lt;0.5 ug/</a:t>
            </a:r>
            <a:r>
              <a:rPr lang="da-DK" dirty="0" err="1"/>
              <a:t>mL</a:t>
            </a:r>
            <a:r>
              <a:rPr lang="da-DK" dirty="0"/>
              <a:t>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53353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F35D3-9E03-AA38-703B-99FDDAC9C6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facto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383F4A-8BAC-AEB5-CFA9-5D6D130D76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artial thromboplastin time      65 sec		(60-70 sec)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Prothrombin time/international normalized ratio   </a:t>
            </a:r>
          </a:p>
          <a:p>
            <a:pPr marL="0" indent="0">
              <a:buNone/>
            </a:pPr>
            <a:r>
              <a:rPr lang="en-US" dirty="0"/>
              <a:t> 20 sec/1.7						(11.9-14.2 sec, 0.9-1.1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48076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5C3CC-40D9-648F-3DA0-CB8A0411B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ain natriuretic peptide (BN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21D9D-81E6-77A6-D8D4-CD69687580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20 </a:t>
            </a:r>
            <a:r>
              <a:rPr lang="en-US" dirty="0" err="1"/>
              <a:t>pg</a:t>
            </a:r>
            <a:r>
              <a:rPr lang="en-US" dirty="0"/>
              <a:t>/mL							(0-100 </a:t>
            </a:r>
            <a:r>
              <a:rPr lang="en-US" dirty="0" err="1"/>
              <a:t>pg</a:t>
            </a:r>
            <a:r>
              <a:rPr lang="en-US" dirty="0"/>
              <a:t>/mL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114583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089FC-8642-BC7A-2AA1-CC327B2FE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T angiography (CTA) of the ches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C4BB29-D9DB-6397-5179-B671069FC2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4" name="Picture 3" descr="68.2 - Aortic dissection">
            <a:extLst>
              <a:ext uri="{FF2B5EF4-FFF2-40B4-BE49-F238E27FC236}">
                <a16:creationId xmlns:a16="http://schemas.microsoft.com/office/drawing/2014/main" id="{62ED9CBA-C57D-59EB-4F78-2A8402E717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451" y="1825625"/>
            <a:ext cx="6195097" cy="450315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212022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97D6B-D8DC-B2AF-3EEA-91CAE9D356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ferior STEMI EC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7ABCF-7B33-5F08-D574-ACBD13FFC8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6EA21FD-D1AC-6B54-0DA5-85BC1DC770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2168" y="1503230"/>
            <a:ext cx="8247664" cy="450361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309971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5B683-6AB5-F705-4644-35BFC37E7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vious EC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F2944A-C0C7-21F7-1740-DABC907644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4BD421F-DD62-5DDA-A578-5A4871B10D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7653" y="1396926"/>
            <a:ext cx="8096693" cy="478535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125401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F033FD-E839-E493-B51C-069ECCD3F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rtable CXR with widened mediastin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D64539-FB9D-8052-8D77-294FEDEF7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469 - wide mediastinum - chest X-ray">
            <a:extLst>
              <a:ext uri="{FF2B5EF4-FFF2-40B4-BE49-F238E27FC236}">
                <a16:creationId xmlns:a16="http://schemas.microsoft.com/office/drawing/2014/main" id="{4F650226-5B05-D719-5E92-191FDA279C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200" y="1468755"/>
            <a:ext cx="5943600" cy="502412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9582005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607CDE-B1E4-08DF-BC7E-1319A9D5D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vious CXR accessed by Picture Archiving and Communication System (PACS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64B7D2-110D-F3CF-8094-C8E5DAB342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9286B36-8B0D-63CA-2C7B-316D4EBA78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3492" y="2030508"/>
            <a:ext cx="4245015" cy="428139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723268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59A94-9E95-402C-24B7-A62021CD31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4D290E-A618-A0CF-0DCD-6079DAB6DD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   14.2 x1000/mm</a:t>
            </a:r>
            <a:r>
              <a:rPr lang="en-US" baseline="30000" dirty="0"/>
              <a:t>3</a:t>
            </a:r>
            <a:r>
              <a:rPr lang="en-US" dirty="0"/>
              <a:t>	       (3.7-10.1x1000/mm</a:t>
            </a:r>
            <a:r>
              <a:rPr lang="en-US" baseline="30000" dirty="0"/>
              <a:t>3</a:t>
            </a:r>
            <a:r>
              <a:rPr lang="en-US" dirty="0"/>
              <a:t>)</a:t>
            </a:r>
          </a:p>
          <a:p>
            <a:pPr marL="0" indent="0">
              <a:buNone/>
            </a:pPr>
            <a:r>
              <a:rPr lang="en-US" dirty="0"/>
              <a:t>Hemoglobin (Hgb)    13.5 g/dL			       (13.4-16.8 g/dL)</a:t>
            </a:r>
          </a:p>
          <a:p>
            <a:pPr marL="0" indent="0">
              <a:buNone/>
            </a:pPr>
            <a:r>
              <a:rPr lang="en-US" dirty="0"/>
              <a:t>Hematocrit (HCT)    40.5% 			       (39.6-48.8%)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    180 x1000/mm</a:t>
            </a:r>
            <a:r>
              <a:rPr lang="en-US" baseline="30000" dirty="0"/>
              <a:t>3</a:t>
            </a:r>
            <a:r>
              <a:rPr lang="en-US" dirty="0"/>
              <a:t>  		       (146-337x1000/mm</a:t>
            </a:r>
            <a:r>
              <a:rPr lang="en-US" baseline="30000" dirty="0"/>
              <a:t>3</a:t>
            </a:r>
            <a:r>
              <a:rPr lang="en-US" dirty="0"/>
              <a:t>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03658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2ACEB-76CA-2A54-A697-E5D3F2045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7F5682-E5F3-D148-829C-F283E48D0B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indent="0">
              <a:buNone/>
            </a:pPr>
            <a:r>
              <a:rPr lang="de-DE" dirty="0"/>
              <a:t>Sodium      133 </a:t>
            </a:r>
            <a:r>
              <a:rPr lang="de-DE" dirty="0" err="1"/>
              <a:t>mEq</a:t>
            </a:r>
            <a:r>
              <a:rPr lang="de-DE" dirty="0"/>
              <a:t>/L 					(133-143 </a:t>
            </a:r>
            <a:r>
              <a:rPr lang="de-DE" dirty="0" err="1"/>
              <a:t>mEq</a:t>
            </a:r>
            <a:r>
              <a:rPr lang="de-DE" dirty="0"/>
              <a:t>/L)</a:t>
            </a:r>
            <a:endParaRPr lang="en-US" dirty="0"/>
          </a:p>
          <a:p>
            <a:pPr marL="0" indent="0">
              <a:buNone/>
            </a:pPr>
            <a:r>
              <a:rPr lang="de-DE" dirty="0"/>
              <a:t>Chloride       99 </a:t>
            </a:r>
            <a:r>
              <a:rPr lang="de-DE" dirty="0" err="1"/>
              <a:t>mEq</a:t>
            </a:r>
            <a:r>
              <a:rPr lang="de-DE" dirty="0"/>
              <a:t>/L 					(98-108 </a:t>
            </a:r>
            <a:r>
              <a:rPr lang="de-DE" dirty="0" err="1"/>
              <a:t>mEq</a:t>
            </a:r>
            <a:r>
              <a:rPr lang="de-DE" dirty="0"/>
              <a:t>/L)</a:t>
            </a:r>
            <a:endParaRPr lang="en-US" dirty="0"/>
          </a:p>
          <a:p>
            <a:pPr marL="0" indent="0">
              <a:buNone/>
            </a:pPr>
            <a:r>
              <a:rPr lang="de-DE" dirty="0"/>
              <a:t>Potassium     4.2 </a:t>
            </a:r>
            <a:r>
              <a:rPr lang="de-DE" dirty="0" err="1"/>
              <a:t>mEq</a:t>
            </a:r>
            <a:r>
              <a:rPr lang="de-DE" dirty="0"/>
              <a:t>/L 					(3.5-5.0 </a:t>
            </a:r>
            <a:r>
              <a:rPr lang="de-DE" dirty="0" err="1"/>
              <a:t>mEq</a:t>
            </a:r>
            <a:r>
              <a:rPr lang="de-DE" dirty="0"/>
              <a:t>/L)</a:t>
            </a:r>
            <a:endParaRPr lang="en-US" dirty="0"/>
          </a:p>
          <a:p>
            <a:pPr marL="0" indent="0">
              <a:buNone/>
            </a:pPr>
            <a:r>
              <a:rPr lang="it-IT" dirty="0" err="1"/>
              <a:t>Bicarbonate</a:t>
            </a:r>
            <a:r>
              <a:rPr lang="it-IT" dirty="0"/>
              <a:t> (HCO3)   25 </a:t>
            </a:r>
            <a:r>
              <a:rPr lang="it-IT" dirty="0" err="1"/>
              <a:t>mEq</a:t>
            </a:r>
            <a:r>
              <a:rPr lang="it-IT" dirty="0"/>
              <a:t>/L  			(23-30 </a:t>
            </a:r>
            <a:r>
              <a:rPr lang="it-IT" dirty="0" err="1"/>
              <a:t>mEq</a:t>
            </a:r>
            <a:r>
              <a:rPr lang="it-IT" dirty="0"/>
              <a:t>/L)</a:t>
            </a:r>
            <a:endParaRPr lang="en-US" dirty="0"/>
          </a:p>
          <a:p>
            <a:pPr marL="0" indent="0">
              <a:buNone/>
            </a:pPr>
            <a:r>
              <a:rPr lang="it-IT" dirty="0"/>
              <a:t>Blood Urea </a:t>
            </a:r>
            <a:r>
              <a:rPr lang="it-IT" dirty="0" err="1"/>
              <a:t>Nitrogen</a:t>
            </a:r>
            <a:r>
              <a:rPr lang="it-IT" dirty="0"/>
              <a:t> (BUN)  38 mg/</a:t>
            </a:r>
            <a:r>
              <a:rPr lang="it-IT" dirty="0" err="1"/>
              <a:t>dL</a:t>
            </a:r>
            <a:r>
              <a:rPr lang="it-IT" dirty="0"/>
              <a:t>   		(6-24 mg/</a:t>
            </a:r>
            <a:r>
              <a:rPr lang="it-IT" dirty="0" err="1"/>
              <a:t>dL</a:t>
            </a:r>
            <a:r>
              <a:rPr lang="it-IT" dirty="0"/>
              <a:t>)</a:t>
            </a:r>
            <a:endParaRPr lang="en-US" dirty="0"/>
          </a:p>
          <a:p>
            <a:pPr marL="0" indent="0">
              <a:buNone/>
            </a:pPr>
            <a:r>
              <a:rPr lang="it-IT" dirty="0"/>
              <a:t>Creatinine (Cr)     1.1 mg/</a:t>
            </a:r>
            <a:r>
              <a:rPr lang="it-IT" dirty="0" err="1"/>
              <a:t>dL</a:t>
            </a:r>
            <a:r>
              <a:rPr lang="it-IT" dirty="0"/>
              <a:t>  				(0.7-1.3 mg/</a:t>
            </a:r>
            <a:r>
              <a:rPr lang="it-IT" dirty="0" err="1"/>
              <a:t>dL</a:t>
            </a:r>
            <a:r>
              <a:rPr lang="it-IT" dirty="0"/>
              <a:t>)</a:t>
            </a:r>
            <a:endParaRPr lang="en-US" dirty="0"/>
          </a:p>
          <a:p>
            <a:pPr marL="0" indent="0">
              <a:buNone/>
            </a:pPr>
            <a:r>
              <a:rPr lang="it-IT" dirty="0" err="1"/>
              <a:t>Glucose</a:t>
            </a:r>
            <a:r>
              <a:rPr lang="it-IT" dirty="0"/>
              <a:t>      100 mg/</a:t>
            </a:r>
            <a:r>
              <a:rPr lang="it-IT" dirty="0" err="1"/>
              <a:t>dL</a:t>
            </a:r>
            <a:r>
              <a:rPr lang="it-IT" dirty="0"/>
              <a:t> 					(70-100 mg/</a:t>
            </a:r>
            <a:r>
              <a:rPr lang="it-IT" dirty="0" err="1"/>
              <a:t>dL</a:t>
            </a:r>
            <a:r>
              <a:rPr lang="it-IT" dirty="0"/>
              <a:t>)</a:t>
            </a:r>
            <a:endParaRPr lang="en-US" dirty="0"/>
          </a:p>
          <a:p>
            <a:pPr marL="0" indent="0">
              <a:buNone/>
            </a:pPr>
            <a:r>
              <a:rPr lang="it-IT" dirty="0" err="1"/>
              <a:t>Calcium</a:t>
            </a:r>
            <a:r>
              <a:rPr lang="it-IT" dirty="0"/>
              <a:t>     8.0 mg/</a:t>
            </a:r>
            <a:r>
              <a:rPr lang="it-IT" dirty="0" err="1"/>
              <a:t>dL</a:t>
            </a:r>
            <a:r>
              <a:rPr lang="it-IT" dirty="0"/>
              <a:t> 					(8.6-10.5 mg/</a:t>
            </a:r>
            <a:r>
              <a:rPr lang="it-IT" dirty="0" err="1"/>
              <a:t>dL</a:t>
            </a:r>
            <a:r>
              <a:rPr lang="it-IT" dirty="0"/>
              <a:t>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46080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E310C-295F-49DC-7EC6-08EB554A6F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Tes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F40F83-2001-72DF-AED8-3CF11905E2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indent="0">
              <a:buNone/>
            </a:pPr>
            <a:r>
              <a:rPr lang="en-US" dirty="0"/>
              <a:t>Total bilirubin    1.4 mg/dL				(&lt;1.5 mg/dL)</a:t>
            </a:r>
          </a:p>
          <a:p>
            <a:pPr marL="0" indent="0">
              <a:buNone/>
            </a:pPr>
            <a:r>
              <a:rPr lang="en-US" dirty="0"/>
              <a:t>Direct bilirubin    0.2 mg/dL				(&lt;0.3 mg/dL)</a:t>
            </a:r>
          </a:p>
          <a:p>
            <a:pPr marL="0" indent="0">
              <a:buNone/>
            </a:pPr>
            <a:r>
              <a:rPr lang="en-US" dirty="0"/>
              <a:t>Aspartate transaminase     39 units/L			(10-39 units/L)</a:t>
            </a:r>
          </a:p>
          <a:p>
            <a:pPr marL="0" indent="0">
              <a:buNone/>
            </a:pPr>
            <a:r>
              <a:rPr lang="en-US" dirty="0"/>
              <a:t>Alanine aminotransferase    13 units/L			(10-52 units/L)</a:t>
            </a:r>
          </a:p>
          <a:p>
            <a:pPr marL="0" indent="0">
              <a:buNone/>
            </a:pPr>
            <a:r>
              <a:rPr lang="en-US" dirty="0"/>
              <a:t>Albumin      4.1 g/dL					(3.5-5.0 g/dL)</a:t>
            </a:r>
          </a:p>
          <a:p>
            <a:pPr marL="0" indent="0">
              <a:buNone/>
            </a:pPr>
            <a:r>
              <a:rPr lang="fr-FR" dirty="0" err="1"/>
              <a:t>Alkaline</a:t>
            </a:r>
            <a:r>
              <a:rPr lang="fr-FR" dirty="0"/>
              <a:t> phosphatase      90 </a:t>
            </a:r>
            <a:r>
              <a:rPr lang="fr-FR" dirty="0" err="1"/>
              <a:t>units</a:t>
            </a:r>
            <a:r>
              <a:rPr lang="fr-FR" dirty="0"/>
              <a:t>/L			(32-126 </a:t>
            </a:r>
            <a:r>
              <a:rPr lang="fr-FR" dirty="0" err="1"/>
              <a:t>units</a:t>
            </a:r>
            <a:r>
              <a:rPr lang="fr-FR" dirty="0"/>
              <a:t>/L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90584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042AC-849A-AD8A-BCA7-F3615E657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ip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E6978-5DF5-A55C-3428-79A3EB45D2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fr-FR" dirty="0"/>
              <a:t>155 </a:t>
            </a:r>
            <a:r>
              <a:rPr lang="fr-FR" dirty="0" err="1"/>
              <a:t>units</a:t>
            </a:r>
            <a:r>
              <a:rPr lang="fr-FR" dirty="0"/>
              <a:t>/L							(10-140 </a:t>
            </a:r>
            <a:r>
              <a:rPr lang="fr-FR" dirty="0" err="1"/>
              <a:t>units</a:t>
            </a:r>
            <a:r>
              <a:rPr lang="fr-FR" dirty="0"/>
              <a:t>/L)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2093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526</Words>
  <Application>Microsoft Macintosh PowerPoint</Application>
  <PresentationFormat>Widescreen</PresentationFormat>
  <Paragraphs>48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Stimulus Inventory</vt:lpstr>
      <vt:lpstr>Inferior STEMI ECG</vt:lpstr>
      <vt:lpstr>Previous ECG</vt:lpstr>
      <vt:lpstr>Portable CXR with widened mediastinum</vt:lpstr>
      <vt:lpstr>Previous CXR accessed by Picture Archiving and Communication System (PACS)</vt:lpstr>
      <vt:lpstr>Complete blood count (CBC)</vt:lpstr>
      <vt:lpstr>Basic metabolic panel (BMP)</vt:lpstr>
      <vt:lpstr>Hepatic Function Test</vt:lpstr>
      <vt:lpstr>Lipase</vt:lpstr>
      <vt:lpstr>Calcium</vt:lpstr>
      <vt:lpstr>Magnesium</vt:lpstr>
      <vt:lpstr>Phosphorous</vt:lpstr>
      <vt:lpstr>Troponin, low-sensitivity</vt:lpstr>
      <vt:lpstr>Troponin, high-sensitivity </vt:lpstr>
      <vt:lpstr>D-dimer</vt:lpstr>
      <vt:lpstr>Coagulation factors</vt:lpstr>
      <vt:lpstr>Brain natriuretic peptide (BNP)</vt:lpstr>
      <vt:lpstr>CT angiography (CTA) of the ches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Low, Cheyenne</dc:creator>
  <cp:lastModifiedBy>Low, Cheyenne</cp:lastModifiedBy>
  <cp:revision>12</cp:revision>
  <dcterms:created xsi:type="dcterms:W3CDTF">2022-06-26T02:51:15Z</dcterms:created>
  <dcterms:modified xsi:type="dcterms:W3CDTF">2022-06-26T03:35:37Z</dcterms:modified>
</cp:coreProperties>
</file>